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CH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831AF9-458E-4261-932A-1940676EED40}" type="datetime">
              <a:rPr b="0" lang="de-CH" sz="1200" spc="-1" strike="noStrike">
                <a:solidFill>
                  <a:srgbClr val="000000"/>
                </a:solidFill>
                <a:latin typeface="Arial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CH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F152202-A53E-4C3D-8980-02424B61FE4B}" type="slidenum">
              <a:rPr b="0" lang="de-CH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CH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6AFEBCE-36BA-4115-97BD-FB0235A80A8D}" type="slidenum">
              <a:rPr b="0" lang="de-CH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29267-6A6B-4DB1-8579-191C12C1D5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7ADAF-0199-47D3-A8F4-0BF58834CB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F1FBF-F270-4CD2-B27E-1BFE1CF1F5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AB74B-5476-4E5A-A357-F847DEB29C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50204-1DA0-4008-BC02-CE7DDBC84E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4D89D-0774-4BC6-8013-E8F9889D72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D6D1A-9537-4770-8978-E4BDE5AC38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EDE1C-A6B7-4363-B055-01E1F44109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3901A-BC64-47EB-943D-ECE94A4EA2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264EA-B2B4-4BB6-B900-094D87AA49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80F13-F2AC-46AF-ABA6-58FB8AB5AC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64A08-FAF6-4999-8D0A-F79258655B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412CE2A-5395-4927-B7DC-94CEEACB64D6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9191E60-2F1D-43C5-81DB-C3FBF88AE4D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792000" y="93960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</a:t>
            </a:r>
            <a:br>
              <a:rPr sz="1200"/>
            </a:br>
            <a:br>
              <a:rPr sz="1200"/>
            </a:br>
            <a:br>
              <a:rPr sz="1200"/>
            </a:br>
            <a:br>
              <a:rPr sz="1200"/>
            </a:b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582120" y="5370120"/>
            <a:ext cx="7480440" cy="1066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just">
              <a:lnSpc>
                <a:spcPct val="100000"/>
              </a:lnSpc>
              <a:spcBef>
                <a:spcPts val="275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(A) and time to progression (B) of the entire study population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Kaplan-Meier curves of 158 consecutive myeloma patients are depicted for overall survival and time to progression. X-axis in months, Y-axis in percent survival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A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he median overall survival of the study population was 72 months. 42 patients have died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B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edian time to progression was 39 months. 70 patients had a fist progression of the disease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0" y="-38592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Object 6"/>
          <p:cNvGraphicFramePr/>
          <p:nvPr/>
        </p:nvGraphicFramePr>
        <p:xfrm>
          <a:off x="792000" y="2235240"/>
          <a:ext cx="3581640" cy="2409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2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2000" y="2235240"/>
                    <a:ext cx="3581640" cy="240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Rectangle 9"/>
          <p:cNvSpPr/>
          <p:nvPr/>
        </p:nvSpPr>
        <p:spPr>
          <a:xfrm>
            <a:off x="0" y="-38592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8"/>
          <p:cNvGraphicFramePr/>
          <p:nvPr/>
        </p:nvGraphicFramePr>
        <p:xfrm>
          <a:off x="4373640" y="2235240"/>
          <a:ext cx="3581280" cy="2409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5" name="Object 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373640" y="2235240"/>
                    <a:ext cx="3581280" cy="240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87520" y="223560"/>
            <a:ext cx="8229600" cy="4143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3"/>
          <p:cNvSpPr/>
          <p:nvPr/>
        </p:nvSpPr>
        <p:spPr>
          <a:xfrm>
            <a:off x="587520" y="6159600"/>
            <a:ext cx="748980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Distribution of the number of circulating CD34+ cells at the day of stem cell collection from all 158 patients in this study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Waterfall diagram presentation of the number of CD34+ cells from all patients. The value of 100’000 CD34+ cells/ml separated the 69 super mobilizers (upper bars) from the 89 normal mobilizers (lower bars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6"/>
          <p:cNvSpPr/>
          <p:nvPr/>
        </p:nvSpPr>
        <p:spPr>
          <a:xfrm>
            <a:off x="0" y="-28404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7"/>
          <p:cNvSpPr/>
          <p:nvPr/>
        </p:nvSpPr>
        <p:spPr>
          <a:xfrm>
            <a:off x="0" y="-28404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9"/>
          <p:cNvSpPr/>
          <p:nvPr/>
        </p:nvSpPr>
        <p:spPr>
          <a:xfrm>
            <a:off x="0" y="-28404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1"/>
          <p:cNvSpPr/>
          <p:nvPr/>
        </p:nvSpPr>
        <p:spPr>
          <a:xfrm>
            <a:off x="0" y="-28404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Object 10"/>
          <p:cNvGraphicFramePr/>
          <p:nvPr/>
        </p:nvGraphicFramePr>
        <p:xfrm>
          <a:off x="1697040" y="638280"/>
          <a:ext cx="5753160" cy="5343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3" name="Object 1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97040" y="638280"/>
                    <a:ext cx="5753160" cy="534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" name="Textfeld 9"/>
          <p:cNvSpPr/>
          <p:nvPr/>
        </p:nvSpPr>
        <p:spPr>
          <a:xfrm>
            <a:off x="976320" y="2260440"/>
            <a:ext cx="18576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hteck 10"/>
          <p:cNvSpPr/>
          <p:nvPr/>
        </p:nvSpPr>
        <p:spPr>
          <a:xfrm>
            <a:off x="2805120" y="5708520"/>
            <a:ext cx="1525680" cy="27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uper mobilizers</a:t>
            </a:r>
            <a:r>
              <a:rPr b="0" lang="de-DE" sz="1200" spc="-1" strike="noStrike">
                <a:solidFill>
                  <a:srgbClr val="ffffff"/>
                </a:solidFill>
                <a:latin typeface="Calibri"/>
              </a:rPr>
              <a:t>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hteck 11"/>
          <p:cNvSpPr/>
          <p:nvPr/>
        </p:nvSpPr>
        <p:spPr>
          <a:xfrm>
            <a:off x="5275440" y="5708520"/>
            <a:ext cx="1442880" cy="27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rmal mobiliz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1T08:19:09Z</dcterms:created>
  <dc:creator>Joëlle Raschle</dc:creator>
  <dc:description/>
  <dc:language>en-US</dc:language>
  <cp:lastModifiedBy>Thomas_Admin</cp:lastModifiedBy>
  <dcterms:modified xsi:type="dcterms:W3CDTF">2011-07-12T08:10:29Z</dcterms:modified>
  <cp:revision>72</cp:revision>
  <dc:subject/>
  <dc:title>Folie 1</dc:title>
</cp:coreProperties>
</file>